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34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สไลด์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377FCE41-2D7F-C5CE-CEE2-1820B76CE3C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ชื่อเรื่องรอง 2">
            <a:extLst>
              <a:ext uri="{FF2B5EF4-FFF2-40B4-BE49-F238E27FC236}">
                <a16:creationId xmlns:a16="http://schemas.microsoft.com/office/drawing/2014/main" id="{21B98322-4375-3CBE-9602-D6FF3DE1C08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h-TH"/>
              <a:t>คลิกเพื่อแก้ไขสไตล์ชื่อเรื่องรอง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A9CFF29D-0F00-0149-C0A4-18A7704AC7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9F5FA-B3E4-453E-AA13-CAF3F29A0EA5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8B7F22AF-8C75-77F8-6A34-445338D41C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3DBB141A-217A-80EB-E978-A80CA000FE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009B9-17CF-4440-A403-9E95ED1EBAA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690081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ชื่อเรื่องและข้อความ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7B13F050-7974-C492-1B9F-9512549DC5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C043B36E-E066-3D00-9D58-A7492D254C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F3A8ACB3-7268-CD98-4215-B2E2B51B8A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9F5FA-B3E4-453E-AA13-CAF3F29A0EA5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CDF19EC3-5D8F-5730-7833-80509A047C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84AC9781-F96D-BF29-9CED-215224AB90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009B9-17CF-4440-A403-9E95ED1EBAA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8181000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ข้อความและชื่อเรื่อง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แนวตั้ง 1">
            <a:extLst>
              <a:ext uri="{FF2B5EF4-FFF2-40B4-BE49-F238E27FC236}">
                <a16:creationId xmlns:a16="http://schemas.microsoft.com/office/drawing/2014/main" id="{FA739BC6-8B67-090A-63D0-DC3E51E4B82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2EB4EC98-3E16-750E-E498-F3112A29B2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00876C5D-0B9C-84B9-853D-DDA5BC24E7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9F5FA-B3E4-453E-AA13-CAF3F29A0EA5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0604E167-2A76-4804-86DD-EACC1E8F93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21D0C43E-EAD2-6C0C-FE21-65968185EB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009B9-17CF-4440-A403-9E95ED1EBAA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6175091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ชื่อเรื่องและเนื้อห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23287EBC-80A9-3D96-5F58-7269A9EDBF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080ACEE0-1C2D-ED49-3C5B-E1850B5452B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579815DB-ECA1-6F0D-E87B-85BF08428C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9F5FA-B3E4-453E-AA13-CAF3F29A0EA5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1895DA09-847E-198D-A1C9-47CFC38CBC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0D7186DE-53E2-96EE-C155-A2D4E3247C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009B9-17CF-4440-A403-9E95ED1EBAA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5812864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ส่วนหัวของ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F497DF99-9FE1-A413-D2C2-6E0D65917A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64F172A6-D797-1D72-4FFD-E5B3DCDABD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A3B0CF6D-76A3-FC4D-B4C7-BA99546F7C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9F5FA-B3E4-453E-AA13-CAF3F29A0EA5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F5911E4F-6DB6-50DB-6FA8-D1B694DFE8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305B982D-AAA3-D40E-8DA4-B38F82F7F0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009B9-17CF-4440-A403-9E95ED1EBAA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070439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เนื้อหา 2 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A8B95F6C-39D0-4E99-4B64-4D7F554651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DBAE4664-78FB-F248-08B4-20C6529F1D0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49CDF58B-3E63-2FD7-CE57-FD55765940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B6673EE4-211B-35F7-534D-181CCF24B7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9F5FA-B3E4-453E-AA13-CAF3F29A0EA5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4D3C97E7-5DF3-6456-1814-3168E1EF79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5254CBA4-80AE-BC00-1B59-18097937BC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009B9-17CF-4440-A403-9E95ED1EBAA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175882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การเปรียบเทียบ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BD6ED92B-85A4-50BA-74DD-323E93C0DD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48BA73CC-D5FA-AE08-0B72-EAE571ED9A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239CB592-20B0-9133-68F0-D4868B1F4A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ข้อความ 4">
            <a:extLst>
              <a:ext uri="{FF2B5EF4-FFF2-40B4-BE49-F238E27FC236}">
                <a16:creationId xmlns:a16="http://schemas.microsoft.com/office/drawing/2014/main" id="{16F00665-A882-0E5B-7131-D721F437EF2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6" name="ตัวแทนเนื้อหา 5">
            <a:extLst>
              <a:ext uri="{FF2B5EF4-FFF2-40B4-BE49-F238E27FC236}">
                <a16:creationId xmlns:a16="http://schemas.microsoft.com/office/drawing/2014/main" id="{D00DE708-2A91-2B8E-D462-7DC0BBCACD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7" name="ตัวแทนวันที่ 6">
            <a:extLst>
              <a:ext uri="{FF2B5EF4-FFF2-40B4-BE49-F238E27FC236}">
                <a16:creationId xmlns:a16="http://schemas.microsoft.com/office/drawing/2014/main" id="{5445F4BB-EF8D-07F6-9ACA-D458F7F64A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9F5FA-B3E4-453E-AA13-CAF3F29A0EA5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8" name="ตัวแทนท้ายกระดาษ 7">
            <a:extLst>
              <a:ext uri="{FF2B5EF4-FFF2-40B4-BE49-F238E27FC236}">
                <a16:creationId xmlns:a16="http://schemas.microsoft.com/office/drawing/2014/main" id="{489274DC-66F7-446C-61D8-1C68585021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ตัวแทนหมายเลขสไลด์ 8">
            <a:extLst>
              <a:ext uri="{FF2B5EF4-FFF2-40B4-BE49-F238E27FC236}">
                <a16:creationId xmlns:a16="http://schemas.microsoft.com/office/drawing/2014/main" id="{25BA5976-E4BC-152F-5432-F0CD6480D7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009B9-17CF-4440-A403-9E95ED1EBAA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8401023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เฉพาะ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BB61618D-5D12-9F3C-77C2-E7830006F4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วันที่ 2">
            <a:extLst>
              <a:ext uri="{FF2B5EF4-FFF2-40B4-BE49-F238E27FC236}">
                <a16:creationId xmlns:a16="http://schemas.microsoft.com/office/drawing/2014/main" id="{5AF82ADC-49FC-7079-2BFB-123688C1A7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9F5FA-B3E4-453E-AA13-CAF3F29A0EA5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4" name="ตัวแทนท้ายกระดาษ 3">
            <a:extLst>
              <a:ext uri="{FF2B5EF4-FFF2-40B4-BE49-F238E27FC236}">
                <a16:creationId xmlns:a16="http://schemas.microsoft.com/office/drawing/2014/main" id="{E69FD248-EF2E-52BF-B2DA-121CFAFEF0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ตัวแทนหมายเลขสไลด์ 4">
            <a:extLst>
              <a:ext uri="{FF2B5EF4-FFF2-40B4-BE49-F238E27FC236}">
                <a16:creationId xmlns:a16="http://schemas.microsoft.com/office/drawing/2014/main" id="{DC49EF1B-1452-0DBC-997A-84856FA2AD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009B9-17CF-4440-A403-9E95ED1EBAA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448846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ว่างเปล่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วันที่ 1">
            <a:extLst>
              <a:ext uri="{FF2B5EF4-FFF2-40B4-BE49-F238E27FC236}">
                <a16:creationId xmlns:a16="http://schemas.microsoft.com/office/drawing/2014/main" id="{21FEB2DA-880C-C379-BB0E-09A65A050D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9F5FA-B3E4-453E-AA13-CAF3F29A0EA5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3" name="ตัวแทนท้ายกระดาษ 2">
            <a:extLst>
              <a:ext uri="{FF2B5EF4-FFF2-40B4-BE49-F238E27FC236}">
                <a16:creationId xmlns:a16="http://schemas.microsoft.com/office/drawing/2014/main" id="{96828269-CA20-7FB5-7106-BEAD99C34E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ตัวแทนหมายเลขสไลด์ 3">
            <a:extLst>
              <a:ext uri="{FF2B5EF4-FFF2-40B4-BE49-F238E27FC236}">
                <a16:creationId xmlns:a16="http://schemas.microsoft.com/office/drawing/2014/main" id="{0702BDB8-D0E1-FD1E-15FE-4A51233B35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009B9-17CF-4440-A403-9E95ED1EBAA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4572435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เนื้อหา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F9394F05-F9FE-316A-F82F-1C506A3729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B3F9FE1B-A08D-036A-03AD-6D1CF48779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6399AA0D-7180-F54E-EC08-CAF7245E17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A335620E-C106-FDE2-2D8A-D197B86678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9F5FA-B3E4-453E-AA13-CAF3F29A0EA5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41C6C512-5A13-86BB-724C-66972A8C6C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3A3AFCA0-4CE4-D42E-BFB6-F2C20BB6F1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009B9-17CF-4440-A403-9E95ED1EBAA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1385874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รูปภาพ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459415D2-C6BA-6DE2-4413-D69404276F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รูปภาพ 2">
            <a:extLst>
              <a:ext uri="{FF2B5EF4-FFF2-40B4-BE49-F238E27FC236}">
                <a16:creationId xmlns:a16="http://schemas.microsoft.com/office/drawing/2014/main" id="{8A8A1C19-3952-8405-C360-BC36C3AE848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h-TH"/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9E337737-236E-5A2E-0DA3-E635CD9500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DCE7397D-8510-8F01-3A23-3E3AF9FD9F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9F5FA-B3E4-453E-AA13-CAF3F29A0EA5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2C01274D-ADAE-7659-B70A-F69D08D194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81A9CA9E-4B2E-AD56-40CD-DDC89786EB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009B9-17CF-4440-A403-9E95ED1EBAA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042083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ชื่อเรื่อง 1">
            <a:extLst>
              <a:ext uri="{FF2B5EF4-FFF2-40B4-BE49-F238E27FC236}">
                <a16:creationId xmlns:a16="http://schemas.microsoft.com/office/drawing/2014/main" id="{90015A6A-D9AF-DFAF-AA4E-B35C246D16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A0EF2624-AA0F-FE79-FE4F-0BD6E046BD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A6C1768F-FF17-CB68-9CFD-00D62800279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19F5FA-B3E4-453E-AA13-CAF3F29A0EA5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87A45F01-D2C8-D2C4-4DA5-9BBAE43DB2F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97E6EA20-8EC1-C868-33FE-50A7037C85C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9009B9-17CF-4440-A403-9E95ED1EBAA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2739112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h-TH"/>
      </a:defPPr>
      <a:lvl1pPr marL="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0">
            <a:extLst>
              <a:ext uri="{FF2B5EF4-FFF2-40B4-BE49-F238E27FC236}">
                <a16:creationId xmlns:a16="http://schemas.microsoft.com/office/drawing/2014/main" id="{00000000-0008-0000-0000-00000A040000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979415" y="1804717"/>
            <a:ext cx="9446950" cy="2197939"/>
          </a:xfrm>
          <a:prstGeom prst="rect">
            <a:avLst/>
          </a:prstGeom>
          <a:noFill/>
        </p:spPr>
      </p:pic>
      <p:sp>
        <p:nvSpPr>
          <p:cNvPr id="4" name="กล่องข้อความ 3">
            <a:extLst>
              <a:ext uri="{FF2B5EF4-FFF2-40B4-BE49-F238E27FC236}">
                <a16:creationId xmlns:a16="http://schemas.microsoft.com/office/drawing/2014/main" id="{02CEAC05-0A40-4DBA-C69B-D4A7C9C4AB2C}"/>
              </a:ext>
            </a:extLst>
          </p:cNvPr>
          <p:cNvSpPr txBox="1"/>
          <p:nvPr/>
        </p:nvSpPr>
        <p:spPr>
          <a:xfrm>
            <a:off x="1775257" y="4075981"/>
            <a:ext cx="10416743" cy="4778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buNone/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Supplementary Figure S3: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 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Chromatogram in + ESI scan mode of the </a:t>
            </a:r>
            <a:r>
              <a:rPr lang="en-US" sz="12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Clerodendrum </a:t>
            </a:r>
            <a:r>
              <a:rPr lang="en-US" sz="1200" b="1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serratum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 (Linn.) Moon (CSM) drying with dehydration chamber, showing the major retention times of detected compounds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3960242882"/>
      </p:ext>
    </p:extLst>
  </p:cSld>
  <p:clrMapOvr>
    <a:masterClrMapping/>
  </p:clrMapOvr>
</p:sld>
</file>

<file path=ppt/theme/theme1.xml><?xml version="1.0" encoding="utf-8"?>
<a:theme xmlns:a="http://schemas.openxmlformats.org/drawingml/2006/main" name="ธีมของ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</Words>
  <Application>Microsoft Office PowerPoint</Application>
  <PresentationFormat>แบบจอกว้าง</PresentationFormat>
  <Paragraphs>1</Paragraphs>
  <Slides>1</Slides>
  <Notes>0</Notes>
  <HiddenSlides>0</HiddenSlides>
  <MMClips>0</MMClips>
  <ScaleCrop>false</ScaleCrop>
  <HeadingPairs>
    <vt:vector size="6" baseType="variant">
      <vt:variant>
        <vt:lpstr>ฟอนต์ที่ถูกใช้</vt:lpstr>
      </vt:variant>
      <vt:variant>
        <vt:i4>4</vt:i4>
      </vt:variant>
      <vt:variant>
        <vt:lpstr>ธีม</vt:lpstr>
      </vt:variant>
      <vt:variant>
        <vt:i4>1</vt:i4>
      </vt:variant>
      <vt:variant>
        <vt:lpstr>ชื่อเรื่องสไลด์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ธีมของ Office</vt:lpstr>
      <vt:lpstr>งานนำเสนอ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กิ่งกาญจน์ บรรลือพืช</dc:creator>
  <cp:lastModifiedBy>กิ่งกาญจน์ บรรลือพืช</cp:lastModifiedBy>
  <cp:revision>1</cp:revision>
  <dcterms:created xsi:type="dcterms:W3CDTF">2026-02-22T09:03:22Z</dcterms:created>
  <dcterms:modified xsi:type="dcterms:W3CDTF">2026-02-22T09:04:11Z</dcterms:modified>
</cp:coreProperties>
</file>